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0" r:id="rId2"/>
  </p:sldIdLst>
  <p:sldSz cx="7588250" cy="10691813"/>
  <p:notesSz cx="6950075" cy="9236075"/>
  <p:defaultTextStyle>
    <a:defPPr>
      <a:defRPr lang="en-US"/>
    </a:defPPr>
    <a:lvl1pPr marL="0" algn="l" defTabSz="957887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1pPr>
    <a:lvl2pPr marL="478944" algn="l" defTabSz="957887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2pPr>
    <a:lvl3pPr marL="957887" algn="l" defTabSz="957887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3pPr>
    <a:lvl4pPr marL="1436831" algn="l" defTabSz="957887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4pPr>
    <a:lvl5pPr marL="1915774" algn="l" defTabSz="957887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5pPr>
    <a:lvl6pPr marL="2394718" algn="l" defTabSz="957887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6pPr>
    <a:lvl7pPr marL="2873661" algn="l" defTabSz="957887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7pPr>
    <a:lvl8pPr marL="3352605" algn="l" defTabSz="957887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8pPr>
    <a:lvl9pPr marL="3831549" algn="l" defTabSz="957887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68" userDrawn="1">
          <p15:clr>
            <a:srgbClr val="A4A3A4"/>
          </p15:clr>
        </p15:guide>
        <p15:guide id="2" pos="239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K Pandey" initials="AP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276" autoAdjust="0"/>
    <p:restoredTop sz="94660"/>
  </p:normalViewPr>
  <p:slideViewPr>
    <p:cSldViewPr>
      <p:cViewPr varScale="1">
        <p:scale>
          <a:sx n="43" d="100"/>
          <a:sy n="43" d="100"/>
        </p:scale>
        <p:origin x="2448" y="68"/>
      </p:cViewPr>
      <p:guideLst>
        <p:guide orient="horz" pos="3368"/>
        <p:guide pos="239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96" d="100"/>
        <a:sy n="9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011700" cy="46180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36767" y="0"/>
            <a:ext cx="3011700" cy="46180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E3909C8-BF3A-4EAB-B9A5-A6204233898E}" type="datetimeFigureOut">
              <a:rPr lang="en-IN" smtClean="0"/>
              <a:pPr/>
              <a:t>21-11-2021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6313" y="692150"/>
            <a:ext cx="2457450" cy="34639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5008" y="4387137"/>
            <a:ext cx="5560060" cy="415623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772668"/>
            <a:ext cx="3011700" cy="46180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36767" y="8772668"/>
            <a:ext cx="3011700" cy="46180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662CD8-564F-4CAA-9389-C6C6097619A8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72355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5788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78944" algn="l" defTabSz="95788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57887" algn="l" defTabSz="95788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436831" algn="l" defTabSz="95788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915774" algn="l" defTabSz="95788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394718" algn="l" defTabSz="95788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873661" algn="l" defTabSz="95788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352605" algn="l" defTabSz="95788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831549" algn="l" defTabSz="95788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46313" y="692150"/>
            <a:ext cx="2457450" cy="346392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F662CD8-564F-4CAA-9389-C6C6097619A8}" type="slidenum">
              <a:rPr lang="en-IN" smtClean="0"/>
              <a:pPr/>
              <a:t>1</a:t>
            </a:fld>
            <a:endParaRPr lang="en-IN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9119" y="3321393"/>
            <a:ext cx="6450013" cy="2291811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38239" y="6058696"/>
            <a:ext cx="5311776" cy="2732352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8076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6152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4422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9230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40381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8845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36534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8461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01483" y="428171"/>
            <a:ext cx="1707356" cy="9122691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9413" y="428171"/>
            <a:ext cx="4995598" cy="912269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9419" y="6870481"/>
            <a:ext cx="6450013" cy="2123513"/>
          </a:xfrm>
        </p:spPr>
        <p:txBody>
          <a:bodyPr anchor="t"/>
          <a:lstStyle>
            <a:lvl1pPr algn="l">
              <a:defRPr sz="4216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9419" y="4531649"/>
            <a:ext cx="6450013" cy="2338834"/>
          </a:xfrm>
        </p:spPr>
        <p:txBody>
          <a:bodyPr anchor="b"/>
          <a:lstStyle>
            <a:lvl1pPr marL="0" indent="0">
              <a:buNone/>
              <a:defRPr sz="2108">
                <a:solidFill>
                  <a:schemeClr val="tx1">
                    <a:tint val="75000"/>
                  </a:schemeClr>
                </a:solidFill>
              </a:defRPr>
            </a:lvl1pPr>
            <a:lvl2pPr marL="480764" indent="0">
              <a:buNone/>
              <a:defRPr sz="1907">
                <a:solidFill>
                  <a:schemeClr val="tx1">
                    <a:tint val="75000"/>
                  </a:schemeClr>
                </a:solidFill>
              </a:defRPr>
            </a:lvl2pPr>
            <a:lvl3pPr marL="961527" indent="0">
              <a:buNone/>
              <a:defRPr sz="1706">
                <a:solidFill>
                  <a:schemeClr val="tx1">
                    <a:tint val="75000"/>
                  </a:schemeClr>
                </a:solidFill>
              </a:defRPr>
            </a:lvl3pPr>
            <a:lvl4pPr marL="1442291" indent="0">
              <a:buNone/>
              <a:defRPr sz="1506">
                <a:solidFill>
                  <a:schemeClr val="tx1">
                    <a:tint val="75000"/>
                  </a:schemeClr>
                </a:solidFill>
              </a:defRPr>
            </a:lvl4pPr>
            <a:lvl5pPr marL="1923054" indent="0">
              <a:buNone/>
              <a:defRPr sz="1506">
                <a:solidFill>
                  <a:schemeClr val="tx1">
                    <a:tint val="75000"/>
                  </a:schemeClr>
                </a:solidFill>
              </a:defRPr>
            </a:lvl5pPr>
            <a:lvl6pPr marL="2403818" indent="0">
              <a:buNone/>
              <a:defRPr sz="1506">
                <a:solidFill>
                  <a:schemeClr val="tx1">
                    <a:tint val="75000"/>
                  </a:schemeClr>
                </a:solidFill>
              </a:defRPr>
            </a:lvl6pPr>
            <a:lvl7pPr marL="2884581" indent="0">
              <a:buNone/>
              <a:defRPr sz="1506">
                <a:solidFill>
                  <a:schemeClr val="tx1">
                    <a:tint val="75000"/>
                  </a:schemeClr>
                </a:solidFill>
              </a:defRPr>
            </a:lvl7pPr>
            <a:lvl8pPr marL="3365345" indent="0">
              <a:buNone/>
              <a:defRPr sz="1506">
                <a:solidFill>
                  <a:schemeClr val="tx1">
                    <a:tint val="75000"/>
                  </a:schemeClr>
                </a:solidFill>
              </a:defRPr>
            </a:lvl8pPr>
            <a:lvl9pPr marL="3846109" indent="0">
              <a:buNone/>
              <a:defRPr sz="150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9413" y="2494758"/>
            <a:ext cx="3351477" cy="7056102"/>
          </a:xfrm>
        </p:spPr>
        <p:txBody>
          <a:bodyPr/>
          <a:lstStyle>
            <a:lvl1pPr>
              <a:defRPr sz="2911"/>
            </a:lvl1pPr>
            <a:lvl2pPr>
              <a:defRPr sz="2510"/>
            </a:lvl2pPr>
            <a:lvl3pPr>
              <a:defRPr sz="2108"/>
            </a:lvl3pPr>
            <a:lvl4pPr>
              <a:defRPr sz="1907"/>
            </a:lvl4pPr>
            <a:lvl5pPr>
              <a:defRPr sz="1907"/>
            </a:lvl5pPr>
            <a:lvl6pPr>
              <a:defRPr sz="1907"/>
            </a:lvl6pPr>
            <a:lvl7pPr>
              <a:defRPr sz="1907"/>
            </a:lvl7pPr>
            <a:lvl8pPr>
              <a:defRPr sz="1907"/>
            </a:lvl8pPr>
            <a:lvl9pPr>
              <a:defRPr sz="190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57360" y="2494758"/>
            <a:ext cx="3351477" cy="7056102"/>
          </a:xfrm>
        </p:spPr>
        <p:txBody>
          <a:bodyPr/>
          <a:lstStyle>
            <a:lvl1pPr>
              <a:defRPr sz="2911"/>
            </a:lvl1pPr>
            <a:lvl2pPr>
              <a:defRPr sz="2510"/>
            </a:lvl2pPr>
            <a:lvl3pPr>
              <a:defRPr sz="2108"/>
            </a:lvl3pPr>
            <a:lvl4pPr>
              <a:defRPr sz="1907"/>
            </a:lvl4pPr>
            <a:lvl5pPr>
              <a:defRPr sz="1907"/>
            </a:lvl5pPr>
            <a:lvl6pPr>
              <a:defRPr sz="1907"/>
            </a:lvl6pPr>
            <a:lvl7pPr>
              <a:defRPr sz="1907"/>
            </a:lvl7pPr>
            <a:lvl8pPr>
              <a:defRPr sz="1907"/>
            </a:lvl8pPr>
            <a:lvl9pPr>
              <a:defRPr sz="190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9414" y="2393286"/>
            <a:ext cx="3352795" cy="997407"/>
          </a:xfrm>
        </p:spPr>
        <p:txBody>
          <a:bodyPr anchor="b"/>
          <a:lstStyle>
            <a:lvl1pPr marL="0" indent="0">
              <a:buNone/>
              <a:defRPr sz="2510" b="1"/>
            </a:lvl1pPr>
            <a:lvl2pPr marL="480764" indent="0">
              <a:buNone/>
              <a:defRPr sz="2108" b="1"/>
            </a:lvl2pPr>
            <a:lvl3pPr marL="961527" indent="0">
              <a:buNone/>
              <a:defRPr sz="1907" b="1"/>
            </a:lvl3pPr>
            <a:lvl4pPr marL="1442291" indent="0">
              <a:buNone/>
              <a:defRPr sz="1706" b="1"/>
            </a:lvl4pPr>
            <a:lvl5pPr marL="1923054" indent="0">
              <a:buNone/>
              <a:defRPr sz="1706" b="1"/>
            </a:lvl5pPr>
            <a:lvl6pPr marL="2403818" indent="0">
              <a:buNone/>
              <a:defRPr sz="1706" b="1"/>
            </a:lvl6pPr>
            <a:lvl7pPr marL="2884581" indent="0">
              <a:buNone/>
              <a:defRPr sz="1706" b="1"/>
            </a:lvl7pPr>
            <a:lvl8pPr marL="3365345" indent="0">
              <a:buNone/>
              <a:defRPr sz="1706" b="1"/>
            </a:lvl8pPr>
            <a:lvl9pPr marL="3846109" indent="0">
              <a:buNone/>
              <a:defRPr sz="170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9414" y="3390691"/>
            <a:ext cx="3352795" cy="6160168"/>
          </a:xfrm>
        </p:spPr>
        <p:txBody>
          <a:bodyPr/>
          <a:lstStyle>
            <a:lvl1pPr>
              <a:defRPr sz="2510"/>
            </a:lvl1pPr>
            <a:lvl2pPr>
              <a:defRPr sz="2108"/>
            </a:lvl2pPr>
            <a:lvl3pPr>
              <a:defRPr sz="1907"/>
            </a:lvl3pPr>
            <a:lvl4pPr>
              <a:defRPr sz="1706"/>
            </a:lvl4pPr>
            <a:lvl5pPr>
              <a:defRPr sz="1706"/>
            </a:lvl5pPr>
            <a:lvl6pPr>
              <a:defRPr sz="1706"/>
            </a:lvl6pPr>
            <a:lvl7pPr>
              <a:defRPr sz="1706"/>
            </a:lvl7pPr>
            <a:lvl8pPr>
              <a:defRPr sz="1706"/>
            </a:lvl8pPr>
            <a:lvl9pPr>
              <a:defRPr sz="170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54728" y="2393286"/>
            <a:ext cx="3354112" cy="997407"/>
          </a:xfrm>
        </p:spPr>
        <p:txBody>
          <a:bodyPr anchor="b"/>
          <a:lstStyle>
            <a:lvl1pPr marL="0" indent="0">
              <a:buNone/>
              <a:defRPr sz="2510" b="1"/>
            </a:lvl1pPr>
            <a:lvl2pPr marL="480764" indent="0">
              <a:buNone/>
              <a:defRPr sz="2108" b="1"/>
            </a:lvl2pPr>
            <a:lvl3pPr marL="961527" indent="0">
              <a:buNone/>
              <a:defRPr sz="1907" b="1"/>
            </a:lvl3pPr>
            <a:lvl4pPr marL="1442291" indent="0">
              <a:buNone/>
              <a:defRPr sz="1706" b="1"/>
            </a:lvl4pPr>
            <a:lvl5pPr marL="1923054" indent="0">
              <a:buNone/>
              <a:defRPr sz="1706" b="1"/>
            </a:lvl5pPr>
            <a:lvl6pPr marL="2403818" indent="0">
              <a:buNone/>
              <a:defRPr sz="1706" b="1"/>
            </a:lvl6pPr>
            <a:lvl7pPr marL="2884581" indent="0">
              <a:buNone/>
              <a:defRPr sz="1706" b="1"/>
            </a:lvl7pPr>
            <a:lvl8pPr marL="3365345" indent="0">
              <a:buNone/>
              <a:defRPr sz="1706" b="1"/>
            </a:lvl8pPr>
            <a:lvl9pPr marL="3846109" indent="0">
              <a:buNone/>
              <a:defRPr sz="170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54728" y="3390691"/>
            <a:ext cx="3354112" cy="6160168"/>
          </a:xfrm>
        </p:spPr>
        <p:txBody>
          <a:bodyPr/>
          <a:lstStyle>
            <a:lvl1pPr>
              <a:defRPr sz="2510"/>
            </a:lvl1pPr>
            <a:lvl2pPr>
              <a:defRPr sz="2108"/>
            </a:lvl2pPr>
            <a:lvl3pPr>
              <a:defRPr sz="1907"/>
            </a:lvl3pPr>
            <a:lvl4pPr>
              <a:defRPr sz="1706"/>
            </a:lvl4pPr>
            <a:lvl5pPr>
              <a:defRPr sz="1706"/>
            </a:lvl5pPr>
            <a:lvl6pPr>
              <a:defRPr sz="1706"/>
            </a:lvl6pPr>
            <a:lvl7pPr>
              <a:defRPr sz="1706"/>
            </a:lvl7pPr>
            <a:lvl8pPr>
              <a:defRPr sz="1706"/>
            </a:lvl8pPr>
            <a:lvl9pPr>
              <a:defRPr sz="170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9414" y="425694"/>
            <a:ext cx="2496482" cy="1811669"/>
          </a:xfrm>
        </p:spPr>
        <p:txBody>
          <a:bodyPr anchor="b"/>
          <a:lstStyle>
            <a:lvl1pPr algn="l">
              <a:defRPr sz="2108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66797" y="425695"/>
            <a:ext cx="4242043" cy="9125167"/>
          </a:xfrm>
        </p:spPr>
        <p:txBody>
          <a:bodyPr/>
          <a:lstStyle>
            <a:lvl1pPr>
              <a:defRPr sz="3413"/>
            </a:lvl1pPr>
            <a:lvl2pPr>
              <a:defRPr sz="2911"/>
            </a:lvl2pPr>
            <a:lvl3pPr>
              <a:defRPr sz="2510"/>
            </a:lvl3pPr>
            <a:lvl4pPr>
              <a:defRPr sz="2108"/>
            </a:lvl4pPr>
            <a:lvl5pPr>
              <a:defRPr sz="2108"/>
            </a:lvl5pPr>
            <a:lvl6pPr>
              <a:defRPr sz="2108"/>
            </a:lvl6pPr>
            <a:lvl7pPr>
              <a:defRPr sz="2108"/>
            </a:lvl7pPr>
            <a:lvl8pPr>
              <a:defRPr sz="2108"/>
            </a:lvl8pPr>
            <a:lvl9pPr>
              <a:defRPr sz="2108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9414" y="2237362"/>
            <a:ext cx="2496482" cy="7313498"/>
          </a:xfrm>
        </p:spPr>
        <p:txBody>
          <a:bodyPr/>
          <a:lstStyle>
            <a:lvl1pPr marL="0" indent="0">
              <a:buNone/>
              <a:defRPr sz="1506"/>
            </a:lvl1pPr>
            <a:lvl2pPr marL="480764" indent="0">
              <a:buNone/>
              <a:defRPr sz="1205"/>
            </a:lvl2pPr>
            <a:lvl3pPr marL="961527" indent="0">
              <a:buNone/>
              <a:defRPr sz="1004"/>
            </a:lvl3pPr>
            <a:lvl4pPr marL="1442291" indent="0">
              <a:buNone/>
              <a:defRPr sz="903"/>
            </a:lvl4pPr>
            <a:lvl5pPr marL="1923054" indent="0">
              <a:buNone/>
              <a:defRPr sz="903"/>
            </a:lvl5pPr>
            <a:lvl6pPr marL="2403818" indent="0">
              <a:buNone/>
              <a:defRPr sz="903"/>
            </a:lvl6pPr>
            <a:lvl7pPr marL="2884581" indent="0">
              <a:buNone/>
              <a:defRPr sz="903"/>
            </a:lvl7pPr>
            <a:lvl8pPr marL="3365345" indent="0">
              <a:buNone/>
              <a:defRPr sz="903"/>
            </a:lvl8pPr>
            <a:lvl9pPr marL="3846109" indent="0">
              <a:buNone/>
              <a:defRPr sz="90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7351" y="7484270"/>
            <a:ext cx="4552950" cy="883561"/>
          </a:xfrm>
        </p:spPr>
        <p:txBody>
          <a:bodyPr anchor="b"/>
          <a:lstStyle>
            <a:lvl1pPr algn="l">
              <a:defRPr sz="2108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487351" y="955334"/>
            <a:ext cx="4552950" cy="6415088"/>
          </a:xfrm>
        </p:spPr>
        <p:txBody>
          <a:bodyPr/>
          <a:lstStyle>
            <a:lvl1pPr marL="0" indent="0">
              <a:buNone/>
              <a:defRPr sz="3413"/>
            </a:lvl1pPr>
            <a:lvl2pPr marL="480764" indent="0">
              <a:buNone/>
              <a:defRPr sz="2911"/>
            </a:lvl2pPr>
            <a:lvl3pPr marL="961527" indent="0">
              <a:buNone/>
              <a:defRPr sz="2510"/>
            </a:lvl3pPr>
            <a:lvl4pPr marL="1442291" indent="0">
              <a:buNone/>
              <a:defRPr sz="2108"/>
            </a:lvl4pPr>
            <a:lvl5pPr marL="1923054" indent="0">
              <a:buNone/>
              <a:defRPr sz="2108"/>
            </a:lvl5pPr>
            <a:lvl6pPr marL="2403818" indent="0">
              <a:buNone/>
              <a:defRPr sz="2108"/>
            </a:lvl6pPr>
            <a:lvl7pPr marL="2884581" indent="0">
              <a:buNone/>
              <a:defRPr sz="2108"/>
            </a:lvl7pPr>
            <a:lvl8pPr marL="3365345" indent="0">
              <a:buNone/>
              <a:defRPr sz="2108"/>
            </a:lvl8pPr>
            <a:lvl9pPr marL="3846109" indent="0">
              <a:buNone/>
              <a:defRPr sz="2108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87351" y="8367830"/>
            <a:ext cx="4552950" cy="1254802"/>
          </a:xfrm>
        </p:spPr>
        <p:txBody>
          <a:bodyPr/>
          <a:lstStyle>
            <a:lvl1pPr marL="0" indent="0">
              <a:buNone/>
              <a:defRPr sz="1506"/>
            </a:lvl1pPr>
            <a:lvl2pPr marL="480764" indent="0">
              <a:buNone/>
              <a:defRPr sz="1205"/>
            </a:lvl2pPr>
            <a:lvl3pPr marL="961527" indent="0">
              <a:buNone/>
              <a:defRPr sz="1004"/>
            </a:lvl3pPr>
            <a:lvl4pPr marL="1442291" indent="0">
              <a:buNone/>
              <a:defRPr sz="903"/>
            </a:lvl4pPr>
            <a:lvl5pPr marL="1923054" indent="0">
              <a:buNone/>
              <a:defRPr sz="903"/>
            </a:lvl5pPr>
            <a:lvl6pPr marL="2403818" indent="0">
              <a:buNone/>
              <a:defRPr sz="903"/>
            </a:lvl6pPr>
            <a:lvl7pPr marL="2884581" indent="0">
              <a:buNone/>
              <a:defRPr sz="903"/>
            </a:lvl7pPr>
            <a:lvl8pPr marL="3365345" indent="0">
              <a:buNone/>
              <a:defRPr sz="903"/>
            </a:lvl8pPr>
            <a:lvl9pPr marL="3846109" indent="0">
              <a:buNone/>
              <a:defRPr sz="90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79413" y="428169"/>
            <a:ext cx="6829426" cy="1781969"/>
          </a:xfrm>
          <a:prstGeom prst="rect">
            <a:avLst/>
          </a:prstGeom>
        </p:spPr>
        <p:txBody>
          <a:bodyPr vert="horz" lIns="95789" tIns="47894" rIns="95789" bIns="47894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9413" y="2494758"/>
            <a:ext cx="6829426" cy="7056102"/>
          </a:xfrm>
          <a:prstGeom prst="rect">
            <a:avLst/>
          </a:prstGeom>
        </p:spPr>
        <p:txBody>
          <a:bodyPr vert="horz" lIns="95789" tIns="47894" rIns="95789" bIns="47894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79413" y="9909729"/>
            <a:ext cx="1770591" cy="569240"/>
          </a:xfrm>
          <a:prstGeom prst="rect">
            <a:avLst/>
          </a:prstGeom>
        </p:spPr>
        <p:txBody>
          <a:bodyPr vert="horz" lIns="95789" tIns="47894" rIns="95789" bIns="47894" rtlCol="0" anchor="ctr"/>
          <a:lstStyle>
            <a:lvl1pPr algn="l">
              <a:defRPr sz="120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1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92654" y="9909729"/>
            <a:ext cx="2402946" cy="569240"/>
          </a:xfrm>
          <a:prstGeom prst="rect">
            <a:avLst/>
          </a:prstGeom>
        </p:spPr>
        <p:txBody>
          <a:bodyPr vert="horz" lIns="95789" tIns="47894" rIns="95789" bIns="47894" rtlCol="0" anchor="ctr"/>
          <a:lstStyle>
            <a:lvl1pPr algn="ctr">
              <a:defRPr sz="120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38246" y="9909729"/>
            <a:ext cx="1770591" cy="569240"/>
          </a:xfrm>
          <a:prstGeom prst="rect">
            <a:avLst/>
          </a:prstGeom>
        </p:spPr>
        <p:txBody>
          <a:bodyPr vert="horz" lIns="95789" tIns="47894" rIns="95789" bIns="47894" rtlCol="0" anchor="ctr"/>
          <a:lstStyle>
            <a:lvl1pPr algn="r">
              <a:defRPr sz="120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61527" rtl="0" eaLnBrk="1" latinLnBrk="0" hangingPunct="1">
        <a:spcBef>
          <a:spcPct val="0"/>
        </a:spcBef>
        <a:buNone/>
        <a:defRPr sz="461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60573" indent="-360573" algn="l" defTabSz="961527" rtl="0" eaLnBrk="1" latinLnBrk="0" hangingPunct="1">
        <a:spcBef>
          <a:spcPct val="20000"/>
        </a:spcBef>
        <a:buFont typeface="Arial" pitchFamily="34" charset="0"/>
        <a:buChar char="•"/>
        <a:defRPr sz="3413" kern="1200">
          <a:solidFill>
            <a:schemeClr val="tx1"/>
          </a:solidFill>
          <a:latin typeface="+mn-lt"/>
          <a:ea typeface="+mn-ea"/>
          <a:cs typeface="+mn-cs"/>
        </a:defRPr>
      </a:lvl1pPr>
      <a:lvl2pPr marL="781240" indent="-300477" algn="l" defTabSz="961527" rtl="0" eaLnBrk="1" latinLnBrk="0" hangingPunct="1">
        <a:spcBef>
          <a:spcPct val="20000"/>
        </a:spcBef>
        <a:buFont typeface="Arial" pitchFamily="34" charset="0"/>
        <a:buChar char="–"/>
        <a:defRPr sz="2911" kern="1200">
          <a:solidFill>
            <a:schemeClr val="tx1"/>
          </a:solidFill>
          <a:latin typeface="+mn-lt"/>
          <a:ea typeface="+mn-ea"/>
          <a:cs typeface="+mn-cs"/>
        </a:defRPr>
      </a:lvl2pPr>
      <a:lvl3pPr marL="1201909" indent="-240382" algn="l" defTabSz="961527" rtl="0" eaLnBrk="1" latinLnBrk="0" hangingPunct="1">
        <a:spcBef>
          <a:spcPct val="20000"/>
        </a:spcBef>
        <a:buFont typeface="Arial" pitchFamily="34" charset="0"/>
        <a:buChar char="•"/>
        <a:defRPr sz="2510" kern="1200">
          <a:solidFill>
            <a:schemeClr val="tx1"/>
          </a:solidFill>
          <a:latin typeface="+mn-lt"/>
          <a:ea typeface="+mn-ea"/>
          <a:cs typeface="+mn-cs"/>
        </a:defRPr>
      </a:lvl3pPr>
      <a:lvl4pPr marL="1682673" indent="-240382" algn="l" defTabSz="961527" rtl="0" eaLnBrk="1" latinLnBrk="0" hangingPunct="1">
        <a:spcBef>
          <a:spcPct val="20000"/>
        </a:spcBef>
        <a:buFont typeface="Arial" pitchFamily="34" charset="0"/>
        <a:buChar char="–"/>
        <a:defRPr sz="2108" kern="1200">
          <a:solidFill>
            <a:schemeClr val="tx1"/>
          </a:solidFill>
          <a:latin typeface="+mn-lt"/>
          <a:ea typeface="+mn-ea"/>
          <a:cs typeface="+mn-cs"/>
        </a:defRPr>
      </a:lvl4pPr>
      <a:lvl5pPr marL="2163436" indent="-240382" algn="l" defTabSz="961527" rtl="0" eaLnBrk="1" latinLnBrk="0" hangingPunct="1">
        <a:spcBef>
          <a:spcPct val="20000"/>
        </a:spcBef>
        <a:buFont typeface="Arial" pitchFamily="34" charset="0"/>
        <a:buChar char="»"/>
        <a:defRPr sz="2108" kern="1200">
          <a:solidFill>
            <a:schemeClr val="tx1"/>
          </a:solidFill>
          <a:latin typeface="+mn-lt"/>
          <a:ea typeface="+mn-ea"/>
          <a:cs typeface="+mn-cs"/>
        </a:defRPr>
      </a:lvl5pPr>
      <a:lvl6pPr marL="2644200" indent="-240382" algn="l" defTabSz="961527" rtl="0" eaLnBrk="1" latinLnBrk="0" hangingPunct="1">
        <a:spcBef>
          <a:spcPct val="20000"/>
        </a:spcBef>
        <a:buFont typeface="Arial" pitchFamily="34" charset="0"/>
        <a:buChar char="•"/>
        <a:defRPr sz="2108" kern="1200">
          <a:solidFill>
            <a:schemeClr val="tx1"/>
          </a:solidFill>
          <a:latin typeface="+mn-lt"/>
          <a:ea typeface="+mn-ea"/>
          <a:cs typeface="+mn-cs"/>
        </a:defRPr>
      </a:lvl6pPr>
      <a:lvl7pPr marL="3124963" indent="-240382" algn="l" defTabSz="961527" rtl="0" eaLnBrk="1" latinLnBrk="0" hangingPunct="1">
        <a:spcBef>
          <a:spcPct val="20000"/>
        </a:spcBef>
        <a:buFont typeface="Arial" pitchFamily="34" charset="0"/>
        <a:buChar char="•"/>
        <a:defRPr sz="2108" kern="1200">
          <a:solidFill>
            <a:schemeClr val="tx1"/>
          </a:solidFill>
          <a:latin typeface="+mn-lt"/>
          <a:ea typeface="+mn-ea"/>
          <a:cs typeface="+mn-cs"/>
        </a:defRPr>
      </a:lvl7pPr>
      <a:lvl8pPr marL="3605727" indent="-240382" algn="l" defTabSz="961527" rtl="0" eaLnBrk="1" latinLnBrk="0" hangingPunct="1">
        <a:spcBef>
          <a:spcPct val="20000"/>
        </a:spcBef>
        <a:buFont typeface="Arial" pitchFamily="34" charset="0"/>
        <a:buChar char="•"/>
        <a:defRPr sz="2108" kern="1200">
          <a:solidFill>
            <a:schemeClr val="tx1"/>
          </a:solidFill>
          <a:latin typeface="+mn-lt"/>
          <a:ea typeface="+mn-ea"/>
          <a:cs typeface="+mn-cs"/>
        </a:defRPr>
      </a:lvl8pPr>
      <a:lvl9pPr marL="4086491" indent="-240382" algn="l" defTabSz="961527" rtl="0" eaLnBrk="1" latinLnBrk="0" hangingPunct="1">
        <a:spcBef>
          <a:spcPct val="20000"/>
        </a:spcBef>
        <a:buFont typeface="Arial" pitchFamily="34" charset="0"/>
        <a:buChar char="•"/>
        <a:defRPr sz="210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1527" rtl="0" eaLnBrk="1" latinLnBrk="0" hangingPunct="1">
        <a:defRPr sz="1907" kern="1200">
          <a:solidFill>
            <a:schemeClr val="tx1"/>
          </a:solidFill>
          <a:latin typeface="+mn-lt"/>
          <a:ea typeface="+mn-ea"/>
          <a:cs typeface="+mn-cs"/>
        </a:defRPr>
      </a:lvl1pPr>
      <a:lvl2pPr marL="480764" algn="l" defTabSz="961527" rtl="0" eaLnBrk="1" latinLnBrk="0" hangingPunct="1">
        <a:defRPr sz="1907" kern="1200">
          <a:solidFill>
            <a:schemeClr val="tx1"/>
          </a:solidFill>
          <a:latin typeface="+mn-lt"/>
          <a:ea typeface="+mn-ea"/>
          <a:cs typeface="+mn-cs"/>
        </a:defRPr>
      </a:lvl2pPr>
      <a:lvl3pPr marL="961527" algn="l" defTabSz="961527" rtl="0" eaLnBrk="1" latinLnBrk="0" hangingPunct="1">
        <a:defRPr sz="1907" kern="1200">
          <a:solidFill>
            <a:schemeClr val="tx1"/>
          </a:solidFill>
          <a:latin typeface="+mn-lt"/>
          <a:ea typeface="+mn-ea"/>
          <a:cs typeface="+mn-cs"/>
        </a:defRPr>
      </a:lvl3pPr>
      <a:lvl4pPr marL="1442291" algn="l" defTabSz="961527" rtl="0" eaLnBrk="1" latinLnBrk="0" hangingPunct="1">
        <a:defRPr sz="1907" kern="1200">
          <a:solidFill>
            <a:schemeClr val="tx1"/>
          </a:solidFill>
          <a:latin typeface="+mn-lt"/>
          <a:ea typeface="+mn-ea"/>
          <a:cs typeface="+mn-cs"/>
        </a:defRPr>
      </a:lvl4pPr>
      <a:lvl5pPr marL="1923054" algn="l" defTabSz="961527" rtl="0" eaLnBrk="1" latinLnBrk="0" hangingPunct="1">
        <a:defRPr sz="1907" kern="1200">
          <a:solidFill>
            <a:schemeClr val="tx1"/>
          </a:solidFill>
          <a:latin typeface="+mn-lt"/>
          <a:ea typeface="+mn-ea"/>
          <a:cs typeface="+mn-cs"/>
        </a:defRPr>
      </a:lvl5pPr>
      <a:lvl6pPr marL="2403818" algn="l" defTabSz="961527" rtl="0" eaLnBrk="1" latinLnBrk="0" hangingPunct="1">
        <a:defRPr sz="1907" kern="1200">
          <a:solidFill>
            <a:schemeClr val="tx1"/>
          </a:solidFill>
          <a:latin typeface="+mn-lt"/>
          <a:ea typeface="+mn-ea"/>
          <a:cs typeface="+mn-cs"/>
        </a:defRPr>
      </a:lvl6pPr>
      <a:lvl7pPr marL="2884581" algn="l" defTabSz="961527" rtl="0" eaLnBrk="1" latinLnBrk="0" hangingPunct="1">
        <a:defRPr sz="1907" kern="1200">
          <a:solidFill>
            <a:schemeClr val="tx1"/>
          </a:solidFill>
          <a:latin typeface="+mn-lt"/>
          <a:ea typeface="+mn-ea"/>
          <a:cs typeface="+mn-cs"/>
        </a:defRPr>
      </a:lvl7pPr>
      <a:lvl8pPr marL="3365345" algn="l" defTabSz="961527" rtl="0" eaLnBrk="1" latinLnBrk="0" hangingPunct="1">
        <a:defRPr sz="1907" kern="1200">
          <a:solidFill>
            <a:schemeClr val="tx1"/>
          </a:solidFill>
          <a:latin typeface="+mn-lt"/>
          <a:ea typeface="+mn-ea"/>
          <a:cs typeface="+mn-cs"/>
        </a:defRPr>
      </a:lvl8pPr>
      <a:lvl9pPr marL="3846109" algn="l" defTabSz="961527" rtl="0" eaLnBrk="1" latinLnBrk="0" hangingPunct="1">
        <a:defRPr sz="190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alpha val="99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4589799C-8110-4AAB-89B9-E3A4E8525A55}"/>
              </a:ext>
            </a:extLst>
          </p:cNvPr>
          <p:cNvSpPr txBox="1"/>
          <p:nvPr/>
        </p:nvSpPr>
        <p:spPr>
          <a:xfrm>
            <a:off x="822354" y="1468133"/>
            <a:ext cx="9181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grpSp>
        <p:nvGrpSpPr>
          <p:cNvPr id="4" name="Group 3"/>
          <p:cNvGrpSpPr/>
          <p:nvPr/>
        </p:nvGrpSpPr>
        <p:grpSpPr>
          <a:xfrm>
            <a:off x="1050925" y="5727849"/>
            <a:ext cx="2538848" cy="2928277"/>
            <a:chOff x="684902" y="534941"/>
            <a:chExt cx="2989378" cy="3251119"/>
          </a:xfrm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980DE0CD-FF9D-40FF-BC92-9A92DF23555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8986" b="43705"/>
            <a:stretch/>
          </p:blipFill>
          <p:spPr>
            <a:xfrm>
              <a:off x="949845" y="534941"/>
              <a:ext cx="2724435" cy="2748462"/>
            </a:xfrm>
            <a:prstGeom prst="rect">
              <a:avLst/>
            </a:prstGeom>
          </p:spPr>
        </p:pic>
        <p:sp>
          <p:nvSpPr>
            <p:cNvPr id="17" name="Left Bracket 16">
              <a:extLst>
                <a:ext uri="{FF2B5EF4-FFF2-40B4-BE49-F238E27FC236}">
                  <a16:creationId xmlns:a16="http://schemas.microsoft.com/office/drawing/2014/main" id="{4153CF87-F9A3-4A85-93C2-C742AB563480}"/>
                </a:ext>
              </a:extLst>
            </p:cNvPr>
            <p:cNvSpPr/>
            <p:nvPr/>
          </p:nvSpPr>
          <p:spPr>
            <a:xfrm rot="5400000" flipH="1">
              <a:off x="1225183" y="3147210"/>
              <a:ext cx="35141" cy="344927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18" name="Left Bracket 17">
              <a:extLst>
                <a:ext uri="{FF2B5EF4-FFF2-40B4-BE49-F238E27FC236}">
                  <a16:creationId xmlns:a16="http://schemas.microsoft.com/office/drawing/2014/main" id="{557FABEC-7E5D-4738-95B9-A043102EADD0}"/>
                </a:ext>
              </a:extLst>
            </p:cNvPr>
            <p:cNvSpPr/>
            <p:nvPr/>
          </p:nvSpPr>
          <p:spPr>
            <a:xfrm rot="5400000" flipH="1">
              <a:off x="2037645" y="2761338"/>
              <a:ext cx="35141" cy="1116669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E36A298F-832B-4FDD-8B2B-CAA9D434F56A}"/>
                </a:ext>
              </a:extLst>
            </p:cNvPr>
            <p:cNvSpPr txBox="1"/>
            <p:nvPr/>
          </p:nvSpPr>
          <p:spPr>
            <a:xfrm>
              <a:off x="684902" y="3403785"/>
              <a:ext cx="1182246" cy="3758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 Black" pitchFamily="34" charset="0"/>
                  <a:cs typeface="Times New Roman" pitchFamily="18" charset="0"/>
                </a:rPr>
                <a:t>Phosphate starvation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F67B8BC8-A99E-4A98-BF02-0C9DC7473587}"/>
                </a:ext>
              </a:extLst>
            </p:cNvPr>
            <p:cNvSpPr txBox="1"/>
            <p:nvPr/>
          </p:nvSpPr>
          <p:spPr>
            <a:xfrm>
              <a:off x="1496881" y="3410180"/>
              <a:ext cx="1348262" cy="3758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 Black" pitchFamily="34" charset="0"/>
                  <a:cs typeface="Times New Roman" pitchFamily="18" charset="0"/>
                </a:rPr>
                <a:t>Heat &amp; Drought stress</a:t>
              </a:r>
            </a:p>
          </p:txBody>
        </p:sp>
      </p:grpSp>
      <p:grpSp>
        <p:nvGrpSpPr>
          <p:cNvPr id="32" name="Group 31"/>
          <p:cNvGrpSpPr/>
          <p:nvPr/>
        </p:nvGrpSpPr>
        <p:grpSpPr>
          <a:xfrm>
            <a:off x="3679011" y="5737667"/>
            <a:ext cx="2558700" cy="2763187"/>
            <a:chOff x="4233537" y="732934"/>
            <a:chExt cx="3979323" cy="4309489"/>
          </a:xfrm>
        </p:grpSpPr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D68E1453-8613-4744-9059-531C082C278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6804" b="40646"/>
            <a:stretch/>
          </p:blipFill>
          <p:spPr>
            <a:xfrm>
              <a:off x="4821399" y="732934"/>
              <a:ext cx="3391461" cy="3575830"/>
            </a:xfrm>
            <a:prstGeom prst="rect">
              <a:avLst/>
            </a:prstGeom>
          </p:spPr>
        </p:pic>
        <p:sp>
          <p:nvSpPr>
            <p:cNvPr id="34" name="Left Bracket 33">
              <a:extLst>
                <a:ext uri="{FF2B5EF4-FFF2-40B4-BE49-F238E27FC236}">
                  <a16:creationId xmlns:a16="http://schemas.microsoft.com/office/drawing/2014/main" id="{AD7B0D6F-DFC0-4ED5-8232-ECCEAE36F29D}"/>
                </a:ext>
              </a:extLst>
            </p:cNvPr>
            <p:cNvSpPr/>
            <p:nvPr/>
          </p:nvSpPr>
          <p:spPr>
            <a:xfrm rot="5400000" flipH="1">
              <a:off x="5202627" y="4017090"/>
              <a:ext cx="45719" cy="664716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35" name="Left Bracket 34">
              <a:extLst>
                <a:ext uri="{FF2B5EF4-FFF2-40B4-BE49-F238E27FC236}">
                  <a16:creationId xmlns:a16="http://schemas.microsoft.com/office/drawing/2014/main" id="{373E3510-D6A0-4400-953F-BE8962CD203A}"/>
                </a:ext>
              </a:extLst>
            </p:cNvPr>
            <p:cNvSpPr/>
            <p:nvPr/>
          </p:nvSpPr>
          <p:spPr>
            <a:xfrm rot="5400000" flipH="1">
              <a:off x="6304464" y="3667036"/>
              <a:ext cx="52224" cy="1371326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5B8B4392-519B-44A4-8A00-6517D3F5113F}"/>
                </a:ext>
              </a:extLst>
            </p:cNvPr>
            <p:cNvSpPr txBox="1"/>
            <p:nvPr/>
          </p:nvSpPr>
          <p:spPr>
            <a:xfrm>
              <a:off x="4233537" y="4414585"/>
              <a:ext cx="1591731" cy="4404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i="1" dirty="0">
                  <a:latin typeface="Arial Black" pitchFamily="34" charset="0"/>
                  <a:cs typeface="Arial" panose="020B0604020202020204" pitchFamily="34" charset="0"/>
                </a:rPr>
                <a:t>Septoria </a:t>
              </a:r>
              <a:r>
                <a:rPr lang="en-US" sz="800" i="1" dirty="0" err="1">
                  <a:latin typeface="Arial Black" pitchFamily="34" charset="0"/>
                  <a:cs typeface="Arial" panose="020B0604020202020204" pitchFamily="34" charset="0"/>
                </a:rPr>
                <a:t>tritici</a:t>
              </a:r>
              <a:r>
                <a:rPr lang="en-US" sz="800" i="1" dirty="0">
                  <a:latin typeface="Arial Black" pitchFamily="34" charset="0"/>
                  <a:cs typeface="Arial" panose="020B0604020202020204" pitchFamily="34" charset="0"/>
                </a:rPr>
                <a:t> </a:t>
              </a:r>
              <a:r>
                <a:rPr lang="en-US" sz="800" dirty="0">
                  <a:latin typeface="Arial Black" pitchFamily="34" charset="0"/>
                  <a:cs typeface="Arial" panose="020B0604020202020204" pitchFamily="34" charset="0"/>
                </a:rPr>
                <a:t>infected Seedlings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5C844527-4514-4E05-A51C-68EED77303DA}"/>
                </a:ext>
              </a:extLst>
            </p:cNvPr>
            <p:cNvSpPr txBox="1"/>
            <p:nvPr/>
          </p:nvSpPr>
          <p:spPr>
            <a:xfrm>
              <a:off x="5471549" y="4441783"/>
              <a:ext cx="2133881" cy="6006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 Black" pitchFamily="34" charset="0"/>
                  <a:cs typeface="Arial" panose="020B0604020202020204" pitchFamily="34" charset="0"/>
                </a:rPr>
                <a:t>Stripe rust and powdery mildew time course of infection in seedlings</a:t>
              </a:r>
            </a:p>
          </p:txBody>
        </p:sp>
      </p:grpSp>
      <p:grpSp>
        <p:nvGrpSpPr>
          <p:cNvPr id="38" name="Group 37"/>
          <p:cNvGrpSpPr/>
          <p:nvPr/>
        </p:nvGrpSpPr>
        <p:grpSpPr>
          <a:xfrm>
            <a:off x="1495426" y="1694264"/>
            <a:ext cx="5209254" cy="3028792"/>
            <a:chOff x="632520" y="282381"/>
            <a:chExt cx="5317718" cy="3752300"/>
          </a:xfrm>
        </p:grpSpPr>
        <p:sp>
          <p:nvSpPr>
            <p:cNvPr id="39" name="Left Bracket 38">
              <a:extLst>
                <a:ext uri="{FF2B5EF4-FFF2-40B4-BE49-F238E27FC236}">
                  <a16:creationId xmlns:a16="http://schemas.microsoft.com/office/drawing/2014/main" id="{F53659A4-FEF9-4CBD-83BC-FB74CF99CD30}"/>
                </a:ext>
              </a:extLst>
            </p:cNvPr>
            <p:cNvSpPr/>
            <p:nvPr/>
          </p:nvSpPr>
          <p:spPr>
            <a:xfrm rot="5400000" flipH="1">
              <a:off x="1387846" y="3005911"/>
              <a:ext cx="45721" cy="1035915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40" name="Left Bracket 39">
              <a:extLst>
                <a:ext uri="{FF2B5EF4-FFF2-40B4-BE49-F238E27FC236}">
                  <a16:creationId xmlns:a16="http://schemas.microsoft.com/office/drawing/2014/main" id="{91F200FD-F4DA-4B5D-B108-4615B5C48D17}"/>
                </a:ext>
              </a:extLst>
            </p:cNvPr>
            <p:cNvSpPr/>
            <p:nvPr/>
          </p:nvSpPr>
          <p:spPr>
            <a:xfrm rot="5400000" flipH="1">
              <a:off x="2252023" y="3249657"/>
              <a:ext cx="73362" cy="576064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grpSp>
          <p:nvGrpSpPr>
            <p:cNvPr id="41" name="Group 40"/>
            <p:cNvGrpSpPr/>
            <p:nvPr/>
          </p:nvGrpSpPr>
          <p:grpSpPr>
            <a:xfrm>
              <a:off x="632520" y="282381"/>
              <a:ext cx="5317718" cy="3752300"/>
              <a:chOff x="632520" y="282381"/>
              <a:chExt cx="5317718" cy="3752300"/>
            </a:xfrm>
          </p:grpSpPr>
          <p:pic>
            <p:nvPicPr>
              <p:cNvPr id="43" name="Picture 42">
                <a:extLst>
                  <a:ext uri="{FF2B5EF4-FFF2-40B4-BE49-F238E27FC236}">
                    <a16:creationId xmlns:a16="http://schemas.microsoft.com/office/drawing/2014/main" id="{E095F4F2-396C-415F-952E-FBBF162A851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43333" b="25313"/>
              <a:stretch/>
            </p:blipFill>
            <p:spPr>
              <a:xfrm>
                <a:off x="787977" y="282381"/>
                <a:ext cx="5162261" cy="3218627"/>
              </a:xfrm>
              <a:prstGeom prst="rect">
                <a:avLst/>
              </a:prstGeom>
            </p:spPr>
          </p:pic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4F752A8F-DD75-4E41-B810-23CC6B65A2F2}"/>
                  </a:ext>
                </a:extLst>
              </p:cNvPr>
              <p:cNvSpPr txBox="1"/>
              <p:nvPr/>
            </p:nvSpPr>
            <p:spPr>
              <a:xfrm>
                <a:off x="632520" y="3571569"/>
                <a:ext cx="136815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 Black" pitchFamily="34" charset="0"/>
                    <a:cs typeface="Arial" panose="020B0604020202020204" pitchFamily="34" charset="0"/>
                  </a:rPr>
                  <a:t>Grain tissue specific developmental </a:t>
                </a:r>
                <a:r>
                  <a:rPr lang="en-US" sz="800" dirty="0" err="1">
                    <a:latin typeface="Arial Black" pitchFamily="34" charset="0"/>
                    <a:cs typeface="Arial" panose="020B0604020202020204" pitchFamily="34" charset="0"/>
                  </a:rPr>
                  <a:t>timecourse</a:t>
                </a:r>
                <a:endParaRPr lang="en-US" sz="800" dirty="0">
                  <a:latin typeface="Arial Black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51B8414E-0298-41F3-BD96-4F68458BC8C0}"/>
                  </a:ext>
                </a:extLst>
              </p:cNvPr>
              <p:cNvSpPr txBox="1"/>
              <p:nvPr/>
            </p:nvSpPr>
            <p:spPr>
              <a:xfrm>
                <a:off x="1712640" y="3573016"/>
                <a:ext cx="1296145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 Black" pitchFamily="34" charset="0"/>
                    <a:cs typeface="Arial" panose="020B0604020202020204" pitchFamily="34" charset="0"/>
                  </a:rPr>
                  <a:t>Grain tissue specific expression</a:t>
                </a:r>
              </a:p>
              <a:p>
                <a:pPr algn="ctr"/>
                <a:r>
                  <a:rPr lang="en-US" sz="800" dirty="0">
                    <a:latin typeface="Arial Black" pitchFamily="34" charset="0"/>
                    <a:cs typeface="Arial" panose="020B0604020202020204" pitchFamily="34" charset="0"/>
                  </a:rPr>
                  <a:t>at 12 </a:t>
                </a:r>
                <a:r>
                  <a:rPr lang="en-US" sz="800" dirty="0" err="1">
                    <a:latin typeface="Arial Black" pitchFamily="34" charset="0"/>
                    <a:cs typeface="Arial" panose="020B0604020202020204" pitchFamily="34" charset="0"/>
                  </a:rPr>
                  <a:t>dpa</a:t>
                </a:r>
                <a:endParaRPr lang="en-US" sz="800" dirty="0">
                  <a:latin typeface="Arial Black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35F50023-B1AA-4C11-A114-D01F04FD9916}"/>
                  </a:ext>
                </a:extLst>
              </p:cNvPr>
              <p:cNvSpPr txBox="1"/>
              <p:nvPr/>
            </p:nvSpPr>
            <p:spPr>
              <a:xfrm>
                <a:off x="2720752" y="3574370"/>
                <a:ext cx="237931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 Black" pitchFamily="34" charset="0"/>
                    <a:cs typeface="Arial" panose="020B0604020202020204" pitchFamily="34" charset="0"/>
                  </a:rPr>
                  <a:t>Developmental time-course of Chinese Spring</a:t>
                </a:r>
              </a:p>
            </p:txBody>
          </p:sp>
        </p:grpSp>
        <p:sp>
          <p:nvSpPr>
            <p:cNvPr id="42" name="Left Bracket 41">
              <a:extLst>
                <a:ext uri="{FF2B5EF4-FFF2-40B4-BE49-F238E27FC236}">
                  <a16:creationId xmlns:a16="http://schemas.microsoft.com/office/drawing/2014/main" id="{F53659A4-FEF9-4CBD-83BC-FB74CF99CD30}"/>
                </a:ext>
              </a:extLst>
            </p:cNvPr>
            <p:cNvSpPr/>
            <p:nvPr/>
          </p:nvSpPr>
          <p:spPr>
            <a:xfrm rot="5400000" flipH="1">
              <a:off x="3814017" y="2407744"/>
              <a:ext cx="45719" cy="2232248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</p:grpSp>
      <p:sp>
        <p:nvSpPr>
          <p:cNvPr id="47" name="TextBox 46">
            <a:extLst>
              <a:ext uri="{FF2B5EF4-FFF2-40B4-BE49-F238E27FC236}">
                <a16:creationId xmlns:a16="http://schemas.microsoft.com/office/drawing/2014/main" id="{4589799C-8110-4AAB-89B9-E3A4E8525A55}"/>
              </a:ext>
            </a:extLst>
          </p:cNvPr>
          <p:cNvSpPr txBox="1"/>
          <p:nvPr/>
        </p:nvSpPr>
        <p:spPr>
          <a:xfrm>
            <a:off x="927512" y="5258626"/>
            <a:ext cx="9181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4589799C-8110-4AAB-89B9-E3A4E8525A55}"/>
              </a:ext>
            </a:extLst>
          </p:cNvPr>
          <p:cNvSpPr txBox="1"/>
          <p:nvPr/>
        </p:nvSpPr>
        <p:spPr>
          <a:xfrm>
            <a:off x="3792971" y="5219635"/>
            <a:ext cx="9181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589D6AC-CE5B-4267-A505-FC2F15FAB0D4}"/>
              </a:ext>
            </a:extLst>
          </p:cNvPr>
          <p:cNvSpPr txBox="1"/>
          <p:nvPr/>
        </p:nvSpPr>
        <p:spPr>
          <a:xfrm>
            <a:off x="33747" y="164306"/>
            <a:ext cx="379476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Additional file 12: Fig </a:t>
            </a:r>
            <a:r>
              <a:rPr lang="en-IN" sz="1200" b="1" dirty="0">
                <a:latin typeface="Times New Roman" pitchFamily="18" charset="0"/>
                <a:cs typeface="Times New Roman" pitchFamily="18" charset="0"/>
              </a:rPr>
              <a:t>S9: </a:t>
            </a:r>
            <a:endParaRPr lang="en-IN" sz="1200" dirty="0"/>
          </a:p>
        </p:txBody>
      </p:sp>
    </p:spTree>
    <p:extLst>
      <p:ext uri="{BB962C8B-B14F-4D97-AF65-F5344CB8AC3E}">
        <p14:creationId xmlns:p14="http://schemas.microsoft.com/office/powerpoint/2010/main" val="984942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591</TotalTime>
  <Words>55</Words>
  <Application>Microsoft Office PowerPoint</Application>
  <PresentationFormat>Custom</PresentationFormat>
  <Paragraphs>1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Arial Black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jay pandey</dc:creator>
  <cp:lastModifiedBy>AK Pandey</cp:lastModifiedBy>
  <cp:revision>443</cp:revision>
  <cp:lastPrinted>2021-05-17T05:57:58Z</cp:lastPrinted>
  <dcterms:created xsi:type="dcterms:W3CDTF">2006-08-16T00:00:00Z</dcterms:created>
  <dcterms:modified xsi:type="dcterms:W3CDTF">2021-11-21T09:48:50Z</dcterms:modified>
</cp:coreProperties>
</file>